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s/slide8.xml" ContentType="application/vnd.openxmlformats-officedocument.presentationml.slide+xml"/>
  <Override PartName="/ppt/slides/slide4.xml" ContentType="application/vnd.openxmlformats-officedocument.presentationml.slide+xml"/>
  <Override PartName="/ppt/slides/slide7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5.xml" ContentType="application/vnd.openxmlformats-officedocument.presentationml.slide+xml"/>
  <Override PartName="/ppt/slides/slide3.xml" ContentType="application/vnd.openxmlformats-officedocument.presentationml.slide+xml"/>
  <Override PartName="/ppt/slides/slide6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Layouts/slideLayout6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notesSlides/notesSlide1.xml" ContentType="application/vnd.openxmlformats-officedocument.presentationml.notesSlide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olors3.xml" ContentType="application/vnd.ms-office.chartcolorstyle+xml"/>
  <Override PartName="/ppt/charts/style1.xml" ContentType="application/vnd.ms-office.chartstyle+xml"/>
  <Override PartName="/ppt/charts/chart1.xml" ContentType="application/vnd.openxmlformats-officedocument.drawingml.chart+xml"/>
  <Override PartName="/ppt/theme/theme2.xml" ContentType="application/vnd.openxmlformats-officedocument.theme+xml"/>
  <Override PartName="/ppt/theme/theme1.xml" ContentType="application/vnd.openxmlformats-officedocument.them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3.xml" ContentType="application/vnd.ms-office.chartstyle+xml"/>
  <Override PartName="/ppt/charts/chart3.xml" ContentType="application/vnd.openxmlformats-officedocument.drawingml.chart+xml"/>
  <Override PartName="/ppt/charts/colors2.xml" ContentType="application/vnd.ms-office.chartcolorstyle+xml"/>
  <Override PartName="/ppt/charts/style2.xml" ContentType="application/vnd.ms-office.chartstyle+xml"/>
  <Override PartName="/ppt/notesMasters/notesMaster1.xml" ContentType="application/vnd.openxmlformats-officedocument.presentationml.notesMaster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ppt/presProps.xml" ContentType="application/vnd.openxmlformats-officedocument.presentationml.presProp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56" r:id="rId2"/>
    <p:sldId id="271" r:id="rId3"/>
    <p:sldId id="272" r:id="rId4"/>
    <p:sldId id="274" r:id="rId5"/>
    <p:sldId id="263" r:id="rId6"/>
    <p:sldId id="281" r:id="rId7"/>
    <p:sldId id="282" r:id="rId8"/>
    <p:sldId id="266" r:id="rId9"/>
    <p:sldId id="277" r:id="rId10"/>
    <p:sldId id="269" r:id="rId11"/>
    <p:sldId id="279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09"/>
    <p:restoredTop sz="89252"/>
  </p:normalViewPr>
  <p:slideViewPr>
    <p:cSldViewPr snapToGrid="0" snapToObjects="1">
      <p:cViewPr varScale="1">
        <p:scale>
          <a:sx n="85" d="100"/>
          <a:sy n="85" d="100"/>
        </p:scale>
        <p:origin x="114" y="5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20" Type="http://schemas.openxmlformats.org/officeDocument/2006/relationships/customXml" Target="../customXml/item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customXml" Target="../customXml/item2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jonathanvazquez-perez\Desktop\12282021%20t%20cell\12282021%20T%20cell%20book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Treg</a:t>
            </a:r>
            <a:r>
              <a:rPr lang="en-US" baseline="0"/>
              <a:t> and Tconv ratio</a:t>
            </a:r>
            <a:endParaRPr 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1!$C$91</c:f>
              <c:strCache>
                <c:ptCount val="1"/>
                <c:pt idx="0">
                  <c:v>Treg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92:$B$97</c:f>
              <c:strCache>
                <c:ptCount val="6"/>
                <c:pt idx="0">
                  <c:v>Vehicle</c:v>
                </c:pt>
                <c:pt idx="1">
                  <c:v>Ipilimumab</c:v>
                </c:pt>
                <c:pt idx="2">
                  <c:v>A9 10 uM</c:v>
                </c:pt>
                <c:pt idx="3">
                  <c:v>A9 50 uM</c:v>
                </c:pt>
                <c:pt idx="4">
                  <c:v>D11 10 uM</c:v>
                </c:pt>
                <c:pt idx="5">
                  <c:v>D11 50 uM</c:v>
                </c:pt>
              </c:strCache>
            </c:strRef>
          </c:cat>
          <c:val>
            <c:numRef>
              <c:f>Sheet1!$C$92:$C$97</c:f>
              <c:numCache>
                <c:formatCode>0.00%</c:formatCode>
                <c:ptCount val="6"/>
                <c:pt idx="0">
                  <c:v>0.46600000000000003</c:v>
                </c:pt>
                <c:pt idx="1">
                  <c:v>0.124</c:v>
                </c:pt>
                <c:pt idx="2">
                  <c:v>0.124</c:v>
                </c:pt>
                <c:pt idx="3">
                  <c:v>0.20899999999999999</c:v>
                </c:pt>
                <c:pt idx="4">
                  <c:v>0.185</c:v>
                </c:pt>
                <c:pt idx="5">
                  <c:v>0.101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A8-C246-BD88-D6053D81DC55}"/>
            </c:ext>
          </c:extLst>
        </c:ser>
        <c:ser>
          <c:idx val="1"/>
          <c:order val="1"/>
          <c:tx>
            <c:strRef>
              <c:f>Sheet1!$D$91</c:f>
              <c:strCache>
                <c:ptCount val="1"/>
                <c:pt idx="0">
                  <c:v>T conv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1!$B$92:$B$97</c:f>
              <c:strCache>
                <c:ptCount val="6"/>
                <c:pt idx="0">
                  <c:v>Vehicle</c:v>
                </c:pt>
                <c:pt idx="1">
                  <c:v>Ipilimumab</c:v>
                </c:pt>
                <c:pt idx="2">
                  <c:v>A9 10 uM</c:v>
                </c:pt>
                <c:pt idx="3">
                  <c:v>A9 50 uM</c:v>
                </c:pt>
                <c:pt idx="4">
                  <c:v>D11 10 uM</c:v>
                </c:pt>
                <c:pt idx="5">
                  <c:v>D11 50 uM</c:v>
                </c:pt>
              </c:strCache>
            </c:strRef>
          </c:cat>
          <c:val>
            <c:numRef>
              <c:f>Sheet1!$D$92:$D$97</c:f>
              <c:numCache>
                <c:formatCode>0.00%</c:formatCode>
                <c:ptCount val="6"/>
                <c:pt idx="0">
                  <c:v>0.104</c:v>
                </c:pt>
                <c:pt idx="1">
                  <c:v>0.42699999999999999</c:v>
                </c:pt>
                <c:pt idx="2">
                  <c:v>0.43099999999999999</c:v>
                </c:pt>
                <c:pt idx="3">
                  <c:v>0.496</c:v>
                </c:pt>
                <c:pt idx="4">
                  <c:v>0.40700000000000003</c:v>
                </c:pt>
                <c:pt idx="5">
                  <c:v>0.417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6A8-C246-BD88-D6053D81DC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83515439"/>
        <c:axId val="683517087"/>
      </c:barChart>
      <c:catAx>
        <c:axId val="68351543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3517087"/>
        <c:crosses val="autoZero"/>
        <c:auto val="1"/>
        <c:lblAlgn val="ctr"/>
        <c:lblOffset val="100"/>
        <c:noMultiLvlLbl val="0"/>
      </c:catAx>
      <c:valAx>
        <c:axId val="68351708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351543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31</c:f>
              <c:strCache>
                <c:ptCount val="1"/>
                <c:pt idx="0">
                  <c:v>CD3+CD8+ %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32:$B$37</c:f>
              <c:strCache>
                <c:ptCount val="6"/>
                <c:pt idx="0">
                  <c:v>Vehicle</c:v>
                </c:pt>
                <c:pt idx="1">
                  <c:v>Ipilimumab</c:v>
                </c:pt>
                <c:pt idx="2">
                  <c:v>A9 10 uM</c:v>
                </c:pt>
                <c:pt idx="3">
                  <c:v>A9 50 uM</c:v>
                </c:pt>
                <c:pt idx="4">
                  <c:v>D11 10 uM</c:v>
                </c:pt>
                <c:pt idx="5">
                  <c:v>D11 50 uM</c:v>
                </c:pt>
              </c:strCache>
            </c:strRef>
          </c:cat>
          <c:val>
            <c:numRef>
              <c:f>Sheet1!$C$32:$C$37</c:f>
              <c:numCache>
                <c:formatCode>0.00%</c:formatCode>
                <c:ptCount val="6"/>
                <c:pt idx="0">
                  <c:v>0.182</c:v>
                </c:pt>
                <c:pt idx="1">
                  <c:v>0.17799999999999999</c:v>
                </c:pt>
                <c:pt idx="2">
                  <c:v>0.16700000000000001</c:v>
                </c:pt>
                <c:pt idx="3">
                  <c:v>0.14599999999999999</c:v>
                </c:pt>
                <c:pt idx="4">
                  <c:v>0.22900000000000001</c:v>
                </c:pt>
                <c:pt idx="5">
                  <c:v>0.276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0B7-B843-91E5-4FCF2A4553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6860175"/>
        <c:axId val="687083759"/>
      </c:barChart>
      <c:catAx>
        <c:axId val="68686017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7083759"/>
        <c:crosses val="autoZero"/>
        <c:auto val="1"/>
        <c:lblAlgn val="ctr"/>
        <c:lblOffset val="100"/>
        <c:noMultiLvlLbl val="0"/>
      </c:catAx>
      <c:valAx>
        <c:axId val="687083759"/>
        <c:scaling>
          <c:orientation val="minMax"/>
          <c:min val="0.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686017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75</c:f>
              <c:strCache>
                <c:ptCount val="1"/>
                <c:pt idx="0">
                  <c:v>CD4+CD25+FoxP3+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76:$B$81</c:f>
              <c:strCache>
                <c:ptCount val="6"/>
                <c:pt idx="0">
                  <c:v>Vehicle</c:v>
                </c:pt>
                <c:pt idx="1">
                  <c:v>Ipilimumab</c:v>
                </c:pt>
                <c:pt idx="2">
                  <c:v>A9 10 uM</c:v>
                </c:pt>
                <c:pt idx="3">
                  <c:v>A9 50 uM</c:v>
                </c:pt>
                <c:pt idx="4">
                  <c:v>D11 10 uM</c:v>
                </c:pt>
                <c:pt idx="5">
                  <c:v>D11 50 uM</c:v>
                </c:pt>
              </c:strCache>
            </c:strRef>
          </c:cat>
          <c:val>
            <c:numRef>
              <c:f>Sheet1!$C$76:$C$81</c:f>
              <c:numCache>
                <c:formatCode>0.00%</c:formatCode>
                <c:ptCount val="6"/>
                <c:pt idx="0">
                  <c:v>0.69399999999999995</c:v>
                </c:pt>
                <c:pt idx="1">
                  <c:v>2.87E-2</c:v>
                </c:pt>
                <c:pt idx="2">
                  <c:v>2.9700000000000001E-2</c:v>
                </c:pt>
                <c:pt idx="3">
                  <c:v>6.4799999999999996E-2</c:v>
                </c:pt>
                <c:pt idx="4">
                  <c:v>7.0099999999999996E-2</c:v>
                </c:pt>
                <c:pt idx="5">
                  <c:v>1.280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AA6-B644-9F10-AE3BA9B024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86955999"/>
        <c:axId val="687273343"/>
      </c:barChart>
      <c:catAx>
        <c:axId val="686955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7273343"/>
        <c:crosses val="autoZero"/>
        <c:auto val="1"/>
        <c:lblAlgn val="ctr"/>
        <c:lblOffset val="100"/>
        <c:noMultiLvlLbl val="0"/>
      </c:catAx>
      <c:valAx>
        <c:axId val="68727334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869559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BF605C-4258-3B42-8D56-04DE7ABD63B8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CE784B6-8824-D143-8E04-8146E1411A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593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ll cells have similar size and shape at the population level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E784B6-8824-D143-8E04-8146E1411A0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9325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pilimumab does not affect differences in CD8+ percentages</a:t>
            </a:r>
          </a:p>
          <a:p>
            <a:r>
              <a:rPr lang="en-US" dirty="0"/>
              <a:t>A9 has a dose dependent effect that lowers CD8+ t-cells </a:t>
            </a:r>
          </a:p>
          <a:p>
            <a:r>
              <a:rPr lang="en-US" dirty="0"/>
              <a:t>D11 has a dose dependent effect that higher CD8+ t-cell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E784B6-8824-D143-8E04-8146E1411A0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7914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9 has a dose dependent effect of generating CD4+CD25+FoxP3+ Tregs </a:t>
            </a:r>
          </a:p>
          <a:p>
            <a:r>
              <a:rPr lang="en-US" dirty="0"/>
              <a:t>D11 has a dose dependent effect of lowering levels of CD4+CD25+FoxP3+ 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E784B6-8824-D143-8E04-8146E1411A0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98510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956330-C560-8840-912F-200166C4E5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AB0E02-31B9-4F44-9C61-519706AC1C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7E16BD-F570-8B40-B4CA-29B9153292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192322-E326-2C49-9695-E1987F376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8EC1D6-7A51-CE49-9216-F474ED413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148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24745E-2159-3048-AE73-A03F519021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72C33E6-0FAA-C349-B8D4-2BBD57FF66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E5D44F-601C-7B4E-BB4E-DC591C9C8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14C319-BACE-4341-A55C-0E9AA66FC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B904E-801E-6148-832A-9FBF64CA4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000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FB60C9-0CE5-424E-85F0-EE0A7A6B7A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4CF27F-97D5-B646-9CA4-9C5D5C3E44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4D7C2C-DE40-2348-87D7-9739D4B9E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3FB964-21CE-BC48-AC5B-0DEE7B58C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0F8916-D2DE-FF46-BFAF-CC783E2F86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5026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F858EE-9CC5-D54A-A0C7-C5BC608B7C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55147E-2DE0-6D44-A243-4957758309B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7ABE64-7B57-8146-AFF4-ADE2487B3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10267A-E0E8-E54C-B218-9008DFEF1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81264E-F211-4740-A3C5-D67486A194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8445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86F8DB-BE52-B04F-9901-B4F16B7EEC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ED7C69-694C-544A-B121-49CA459A11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569D01-6D42-6D40-9F27-486E945EF6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62149A-3A71-6748-BC83-7D49EFF29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6CB1AE-2F99-7B4A-B09A-3943FE94D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32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4947ED-44C1-6341-B931-540C5CA14B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6FBA18-C78E-7A41-B9D4-0AF8652095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AF9D41-CE5E-BA4C-8A06-8B7F9FE41B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02F6B43-77CB-D14F-9DAA-F89D322D8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02AF1E-88E4-1A44-80E3-A784340643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86DDCD-AA27-424F-BA5B-D78764D57F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9359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C802D8-E7AD-BC45-832A-08256881B1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FFC708-9EE4-E84D-8040-D078580143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1199E1-F55F-F740-8F1E-BC6CA3E94C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EB1F985-DB1D-E14D-A821-3856A9B26A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636437E-1017-D643-9364-99F0372F04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66A914-30BC-4C46-88D5-D56F44549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88AB743-3A53-1745-B340-5A45223AA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DBF4185-C4C2-8A48-8D5F-A0C786B0A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614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014F7-15B6-FA42-8757-9ABED2C309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A64CB0-5B68-6044-B808-4E667B8A2E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247AA1-EB82-A542-B78F-3903F84A58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4ADF11B-FB8F-1B45-B48E-3714694BA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6092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4D403A-F2B7-614C-997E-BC86C48DC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01E475-7CA1-4943-9872-DE554348F0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4160F72-BDB0-5F43-8F98-B07919167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0133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48B492-CCA5-9E4E-8083-A1508EDAD9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07FE44-CA77-9549-A990-17E31799FC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AC68C8-C5D5-F848-82A4-B964B3D0FA3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CD95C8-FF1F-0A41-B933-5A9AF4DBC1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C2875B8-E6E8-0A4E-A3DB-E1939C8B4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CEAD488-DF55-4643-8699-285F6BC93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2904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8BD38-E812-4F43-9EA2-C3ADBDC58F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B07817-FE07-994E-84CF-C96E42006C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3BE6C18-2CAF-C94A-8B57-97D6FAF0EF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ED6BE5-3F87-5F44-B5DE-F06743A375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104A9E-E0E4-8943-936F-12EC882E9E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6A31D7-7B1F-F64B-A411-9FC7FCA3B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674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C4BDA80-0425-6C40-99BB-818AC23F79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285B4F-08CA-C84B-AC12-DE9F3F48E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351BB-DDD4-B14A-8622-155A5DF67CA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D1D3A-C937-C24F-800D-E023465861AA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CFF89A-9F22-ED47-98CE-2CC164762CB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B3DC-E0B7-5544-8571-AC0ACC9B29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4E2C1-78ED-BA4A-A3D8-4D5BCB9C94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538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A399A2-8A1A-7745-9115-0FA4499E9A0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/>
              <a:t>CTLA-4 small molecule inhibitor pilot experiment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76307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3A356-AF2A-3E40-A7A3-2DF9988284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377335"/>
            <a:ext cx="2207171" cy="1325563"/>
          </a:xfrm>
        </p:spPr>
        <p:txBody>
          <a:bodyPr>
            <a:normAutofit/>
          </a:bodyPr>
          <a:lstStyle/>
          <a:p>
            <a:r>
              <a:rPr lang="en-US" sz="2800"/>
              <a:t>CD3+CD4+: CD25+FoxP3+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5984491-D678-1D4F-B0C8-F856B09A995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0631"/>
          <a:stretch/>
        </p:blipFill>
        <p:spPr>
          <a:xfrm>
            <a:off x="1675837" y="0"/>
            <a:ext cx="8840325" cy="612894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7D5448E-807A-B241-862D-26E54AC47CC0}"/>
              </a:ext>
            </a:extLst>
          </p:cNvPr>
          <p:cNvSpPr txBox="1"/>
          <p:nvPr/>
        </p:nvSpPr>
        <p:spPr>
          <a:xfrm>
            <a:off x="2889899" y="2601514"/>
            <a:ext cx="963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ehicl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1799F67-E653-B14A-96F2-502B5BD3AD11}"/>
              </a:ext>
            </a:extLst>
          </p:cNvPr>
          <p:cNvSpPr txBox="1"/>
          <p:nvPr/>
        </p:nvSpPr>
        <p:spPr>
          <a:xfrm>
            <a:off x="5717464" y="2601514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ilimuma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98E103D-BF7F-5640-ADC5-018936048743}"/>
              </a:ext>
            </a:extLst>
          </p:cNvPr>
          <p:cNvSpPr txBox="1"/>
          <p:nvPr/>
        </p:nvSpPr>
        <p:spPr>
          <a:xfrm>
            <a:off x="8826381" y="2601514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D7B5AB-26BC-B946-BD26-87335B57E2EA}"/>
              </a:ext>
            </a:extLst>
          </p:cNvPr>
          <p:cNvSpPr txBox="1"/>
          <p:nvPr/>
        </p:nvSpPr>
        <p:spPr>
          <a:xfrm>
            <a:off x="2731383" y="6038095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5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58F148-9444-BB41-9529-5C5FDE55C640}"/>
              </a:ext>
            </a:extLst>
          </p:cNvPr>
          <p:cNvSpPr txBox="1"/>
          <p:nvPr/>
        </p:nvSpPr>
        <p:spPr>
          <a:xfrm>
            <a:off x="5740165" y="6038095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A74DC13-5BBC-8F4E-9DAE-7E49155708FC}"/>
              </a:ext>
            </a:extLst>
          </p:cNvPr>
          <p:cNvSpPr txBox="1"/>
          <p:nvPr/>
        </p:nvSpPr>
        <p:spPr>
          <a:xfrm>
            <a:off x="8748943" y="6038095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50 </a:t>
            </a:r>
            <a:r>
              <a:rPr lang="en-US" dirty="0" err="1"/>
              <a:t>uM</a:t>
            </a:r>
            <a:endParaRPr lang="en-US" dirty="0"/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7C0B4F7-5615-5447-8524-764D00DC29E0}"/>
              </a:ext>
            </a:extLst>
          </p:cNvPr>
          <p:cNvCxnSpPr/>
          <p:nvPr/>
        </p:nvCxnSpPr>
        <p:spPr>
          <a:xfrm flipV="1">
            <a:off x="1601756" y="4511058"/>
            <a:ext cx="0" cy="12719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128D02DD-F096-2D43-945D-459B49EF728D}"/>
              </a:ext>
            </a:extLst>
          </p:cNvPr>
          <p:cNvCxnSpPr>
            <a:cxnSpLocks/>
          </p:cNvCxnSpPr>
          <p:nvPr/>
        </p:nvCxnSpPr>
        <p:spPr>
          <a:xfrm>
            <a:off x="1601756" y="5984789"/>
            <a:ext cx="11574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6B241A33-54E4-5A47-82C6-AFA565AE224E}"/>
              </a:ext>
            </a:extLst>
          </p:cNvPr>
          <p:cNvSpPr txBox="1"/>
          <p:nvPr/>
        </p:nvSpPr>
        <p:spPr>
          <a:xfrm>
            <a:off x="1784757" y="6128951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xP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C1A272-303D-D244-B34C-F6DC4BB150A1}"/>
              </a:ext>
            </a:extLst>
          </p:cNvPr>
          <p:cNvSpPr txBox="1"/>
          <p:nvPr/>
        </p:nvSpPr>
        <p:spPr>
          <a:xfrm rot="16200000">
            <a:off x="863200" y="4895222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25</a:t>
            </a:r>
          </a:p>
        </p:txBody>
      </p:sp>
    </p:spTree>
    <p:extLst>
      <p:ext uri="{BB962C8B-B14F-4D97-AF65-F5344CB8AC3E}">
        <p14:creationId xmlns:p14="http://schemas.microsoft.com/office/powerpoint/2010/main" val="36643377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D899F3-3095-F748-932F-50F677A096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dirty="0"/>
              <a:t>CD3+CD4+: CD25+FoxP3+ Tregs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9FC1CEC1-CD93-C24A-A078-9F95DDC111ED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89401606"/>
              </p:ext>
            </p:extLst>
          </p:nvPr>
        </p:nvGraphicFramePr>
        <p:xfrm>
          <a:off x="665217" y="2717800"/>
          <a:ext cx="2159000" cy="1422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458">
                  <a:extLst>
                    <a:ext uri="{9D8B030D-6E8A-4147-A177-3AD203B41FA5}">
                      <a16:colId xmlns:a16="http://schemas.microsoft.com/office/drawing/2014/main" val="3167547323"/>
                    </a:ext>
                  </a:extLst>
                </a:gridCol>
                <a:gridCol w="1331542">
                  <a:extLst>
                    <a:ext uri="{9D8B030D-6E8A-4147-A177-3AD203B41FA5}">
                      <a16:colId xmlns:a16="http://schemas.microsoft.com/office/drawing/2014/main" val="3263158024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D4+CD25+FoxP3+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347753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Vehicl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9.4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63681899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pilimuma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.87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39148355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9 1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.97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388102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9 5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.48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35450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11 1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.01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5499015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11 5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1.28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0899538"/>
                  </a:ext>
                </a:extLst>
              </a:tr>
            </a:tbl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EE81CC95-5544-0444-82CD-BB686ECAFC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4208520"/>
              </p:ext>
            </p:extLst>
          </p:nvPr>
        </p:nvGraphicFramePr>
        <p:xfrm>
          <a:off x="3915104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8655774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DEE952-9BAD-F649-8CA8-083F8B660C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xperimental layou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69A15C-CD70-9448-B8E9-72407AB269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dirty="0"/>
              <a:t>Hypothesis: The addition of candidate CTLA-4 small molecule inhibitors into a DC co-culture with allogeneic PBMC will lead to increased hallmarks of Th1 immunity in a dose dependent manner</a:t>
            </a:r>
          </a:p>
          <a:p>
            <a:r>
              <a:rPr lang="en-US" dirty="0"/>
              <a:t>Read outs: </a:t>
            </a:r>
          </a:p>
          <a:p>
            <a:pPr lvl="1"/>
            <a:r>
              <a:rPr lang="en-US" dirty="0"/>
              <a:t>Flow cytometry: To identify Tregs and IFN-g producing Th1 cells and expansion of CD8+ T-cells</a:t>
            </a:r>
          </a:p>
          <a:p>
            <a:pPr lvl="1"/>
            <a:r>
              <a:rPr lang="en-US" dirty="0"/>
              <a:t>Cytokine bead array: To identify supernatant levels of IFN-g and IL-10 in the DC/PBMC co-cultures</a:t>
            </a:r>
          </a:p>
          <a:p>
            <a:r>
              <a:rPr lang="en-US" dirty="0"/>
              <a:t>6 conditions: (All DC:PBMC co-cultures)</a:t>
            </a:r>
          </a:p>
          <a:p>
            <a:pPr lvl="1"/>
            <a:r>
              <a:rPr lang="en-US" dirty="0"/>
              <a:t>Vehicle (DMF) control</a:t>
            </a:r>
          </a:p>
          <a:p>
            <a:pPr lvl="1"/>
            <a:r>
              <a:rPr lang="en-US" dirty="0"/>
              <a:t>Ipilimumab control at 5 ug/ml</a:t>
            </a:r>
          </a:p>
          <a:p>
            <a:pPr lvl="1"/>
            <a:r>
              <a:rPr lang="en-US" dirty="0"/>
              <a:t>A9 (10 </a:t>
            </a:r>
            <a:r>
              <a:rPr lang="en-US" dirty="0" err="1"/>
              <a:t>uM</a:t>
            </a:r>
            <a:r>
              <a:rPr lang="en-US" dirty="0"/>
              <a:t>)</a:t>
            </a:r>
          </a:p>
          <a:p>
            <a:pPr lvl="1"/>
            <a:r>
              <a:rPr lang="en-US" dirty="0"/>
              <a:t>A9 (50 </a:t>
            </a:r>
            <a:r>
              <a:rPr lang="en-US" dirty="0" err="1"/>
              <a:t>uM</a:t>
            </a:r>
            <a:r>
              <a:rPr lang="en-US" dirty="0"/>
              <a:t>)</a:t>
            </a:r>
          </a:p>
          <a:p>
            <a:pPr lvl="1"/>
            <a:r>
              <a:rPr lang="en-US" dirty="0"/>
              <a:t>D11 (10 </a:t>
            </a:r>
            <a:r>
              <a:rPr lang="en-US" dirty="0" err="1"/>
              <a:t>uM</a:t>
            </a:r>
            <a:r>
              <a:rPr lang="en-US" dirty="0"/>
              <a:t>)</a:t>
            </a:r>
          </a:p>
          <a:p>
            <a:pPr lvl="1"/>
            <a:r>
              <a:rPr lang="en-US" dirty="0"/>
              <a:t>D11 (50 </a:t>
            </a:r>
            <a:r>
              <a:rPr lang="en-US" dirty="0" err="1"/>
              <a:t>uM</a:t>
            </a:r>
            <a:r>
              <a:rPr lang="en-US" dirty="0"/>
              <a:t>)</a:t>
            </a:r>
          </a:p>
          <a:p>
            <a:pPr marL="457200" lvl="1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55002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225AAC-763B-934F-8C7C-512CC378A4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ytokine bead array: relative levels of supernatant IL-10 and IFN-g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5D70E8-8233-194D-AFA8-74272B53A6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n assay that combines ELISA and flow cytometry to detect serum/supernatant levels of an ”analyte” (</a:t>
            </a:r>
            <a:r>
              <a:rPr lang="en-US" dirty="0" err="1"/>
              <a:t>e.g</a:t>
            </a:r>
            <a:r>
              <a:rPr lang="en-US" dirty="0"/>
              <a:t> cytokine) </a:t>
            </a:r>
          </a:p>
          <a:p>
            <a:r>
              <a:rPr lang="en-US" dirty="0"/>
              <a:t>The following data is from day 6 and thus represents immediate levels of cytokine production following DC:T-cell co-culture at day 6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56233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24E1E9-4AF6-674D-9A9B-7EE4BA150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871"/>
            <a:ext cx="10515600" cy="1325563"/>
          </a:xfrm>
        </p:spPr>
        <p:txBody>
          <a:bodyPr/>
          <a:lstStyle/>
          <a:p>
            <a:r>
              <a:rPr lang="en-US" dirty="0"/>
              <a:t>Relative levels of supernatant IFN-g at day 6</a:t>
            </a:r>
          </a:p>
        </p:txBody>
      </p: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E7AF1810-4065-EE45-97CE-7E0864CD75BA}"/>
              </a:ext>
            </a:extLst>
          </p:cNvPr>
          <p:cNvCxnSpPr>
            <a:cxnSpLocks/>
          </p:cNvCxnSpPr>
          <p:nvPr/>
        </p:nvCxnSpPr>
        <p:spPr>
          <a:xfrm>
            <a:off x="1591136" y="2491469"/>
            <a:ext cx="1620044" cy="0"/>
          </a:xfrm>
          <a:prstGeom prst="straightConnector1">
            <a:avLst/>
          </a:prstGeom>
          <a:ln w="130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7F7D2B10-0245-4643-A734-BAA483A92D43}"/>
              </a:ext>
            </a:extLst>
          </p:cNvPr>
          <p:cNvSpPr txBox="1"/>
          <p:nvPr/>
        </p:nvSpPr>
        <p:spPr>
          <a:xfrm>
            <a:off x="487475" y="2258740"/>
            <a:ext cx="1103661" cy="379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FN-</a:t>
            </a:r>
            <a:r>
              <a:rPr lang="en-US" b="1" dirty="0"/>
              <a:t>ϒ</a:t>
            </a:r>
            <a:r>
              <a:rPr lang="en-US" dirty="0" smtClean="0"/>
              <a:t> </a:t>
            </a:r>
            <a:r>
              <a:rPr lang="en-US" dirty="0"/>
              <a:t>MFI </a:t>
            </a:r>
          </a:p>
        </p:txBody>
      </p:sp>
      <p:graphicFrame>
        <p:nvGraphicFramePr>
          <p:cNvPr id="10" name="Table 10">
            <a:extLst>
              <a:ext uri="{FF2B5EF4-FFF2-40B4-BE49-F238E27FC236}">
                <a16:creationId xmlns:a16="http://schemas.microsoft.com/office/drawing/2014/main" id="{C55FABA2-A5CA-AF43-AB16-519B5F94C49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82418461"/>
              </p:ext>
            </p:extLst>
          </p:nvPr>
        </p:nvGraphicFramePr>
        <p:xfrm>
          <a:off x="3211180" y="4337101"/>
          <a:ext cx="4846035" cy="243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5345">
                  <a:extLst>
                    <a:ext uri="{9D8B030D-6E8A-4147-A177-3AD203B41FA5}">
                      <a16:colId xmlns:a16="http://schemas.microsoft.com/office/drawing/2014/main" val="1734444013"/>
                    </a:ext>
                  </a:extLst>
                </a:gridCol>
                <a:gridCol w="1615345">
                  <a:extLst>
                    <a:ext uri="{9D8B030D-6E8A-4147-A177-3AD203B41FA5}">
                      <a16:colId xmlns:a16="http://schemas.microsoft.com/office/drawing/2014/main" val="1020550571"/>
                    </a:ext>
                  </a:extLst>
                </a:gridCol>
                <a:gridCol w="1615345">
                  <a:extLst>
                    <a:ext uri="{9D8B030D-6E8A-4147-A177-3AD203B41FA5}">
                      <a16:colId xmlns:a16="http://schemas.microsoft.com/office/drawing/2014/main" val="3961837416"/>
                    </a:ext>
                  </a:extLst>
                </a:gridCol>
              </a:tblGrid>
              <a:tr h="169124">
                <a:tc>
                  <a:txBody>
                    <a:bodyPr/>
                    <a:lstStyle/>
                    <a:p>
                      <a:r>
                        <a:rPr lang="en-US" sz="1000" dirty="0"/>
                        <a:t>Col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ample nam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Geometric mean (B585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51886837"/>
                  </a:ext>
                </a:extLst>
              </a:tr>
              <a:tr h="225499">
                <a:tc>
                  <a:txBody>
                    <a:bodyPr/>
                    <a:lstStyle/>
                    <a:p>
                      <a:r>
                        <a:rPr lang="en-US" dirty="0"/>
                        <a:t>Dark gre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Vehic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02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749313"/>
                  </a:ext>
                </a:extLst>
              </a:tr>
              <a:tr h="225499">
                <a:tc>
                  <a:txBody>
                    <a:bodyPr/>
                    <a:lstStyle/>
                    <a:p>
                      <a:r>
                        <a:rPr lang="en-US" dirty="0"/>
                        <a:t>Light blu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Ipilimuma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399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8258892"/>
                  </a:ext>
                </a:extLst>
              </a:tr>
              <a:tr h="225499">
                <a:tc>
                  <a:txBody>
                    <a:bodyPr/>
                    <a:lstStyle/>
                    <a:p>
                      <a:r>
                        <a:rPr lang="en-US" dirty="0"/>
                        <a:t>Orang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9 10 </a:t>
                      </a:r>
                      <a:r>
                        <a:rPr lang="en-US" dirty="0" err="1"/>
                        <a:t>uM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80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98314244"/>
                  </a:ext>
                </a:extLst>
              </a:tr>
              <a:tr h="225499">
                <a:tc>
                  <a:txBody>
                    <a:bodyPr/>
                    <a:lstStyle/>
                    <a:p>
                      <a:r>
                        <a:rPr lang="en-US" dirty="0"/>
                        <a:t>Light gre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9 50 </a:t>
                      </a:r>
                      <a:r>
                        <a:rPr lang="en-US" dirty="0" err="1"/>
                        <a:t>uM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898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8801646"/>
                  </a:ext>
                </a:extLst>
              </a:tr>
              <a:tr h="225499">
                <a:tc>
                  <a:txBody>
                    <a:bodyPr/>
                    <a:lstStyle/>
                    <a:p>
                      <a:r>
                        <a:rPr lang="en-US" dirty="0"/>
                        <a:t>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11 10 </a:t>
                      </a:r>
                      <a:r>
                        <a:rPr lang="en-US" dirty="0" err="1"/>
                        <a:t>uM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955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3842886"/>
                  </a:ext>
                </a:extLst>
              </a:tr>
              <a:tr h="225499">
                <a:tc>
                  <a:txBody>
                    <a:bodyPr/>
                    <a:lstStyle/>
                    <a:p>
                      <a:r>
                        <a:rPr lang="en-US" dirty="0"/>
                        <a:t>Pin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11 50 </a:t>
                      </a:r>
                      <a:r>
                        <a:rPr lang="en-US" dirty="0" err="1"/>
                        <a:t>uM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1564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6852190"/>
                  </a:ext>
                </a:extLst>
              </a:tr>
            </a:tbl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A7350855-4C49-C743-873A-F6B7A30F9310}"/>
              </a:ext>
            </a:extLst>
          </p:cNvPr>
          <p:cNvSpPr txBox="1"/>
          <p:nvPr/>
        </p:nvSpPr>
        <p:spPr>
          <a:xfrm>
            <a:off x="9495294" y="2491469"/>
            <a:ext cx="16200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Undiluted supernatant</a:t>
            </a:r>
          </a:p>
        </p:txBody>
      </p:sp>
      <p:pic>
        <p:nvPicPr>
          <p:cNvPr id="15" name="Content Placeholder 3">
            <a:extLst>
              <a:ext uri="{FF2B5EF4-FFF2-40B4-BE49-F238E27FC236}">
                <a16:creationId xmlns:a16="http://schemas.microsoft.com/office/drawing/2014/main" id="{505AE98F-041D-AB4B-8ABD-6B50831650D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r="54223" b="59118"/>
          <a:stretch/>
        </p:blipFill>
        <p:spPr>
          <a:xfrm>
            <a:off x="3335869" y="939594"/>
            <a:ext cx="3929227" cy="3397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06083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3A356-AF2A-3E40-A7A3-2DF9988284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6125" y="2419376"/>
            <a:ext cx="2021975" cy="1325563"/>
          </a:xfrm>
        </p:spPr>
        <p:txBody>
          <a:bodyPr>
            <a:normAutofit/>
          </a:bodyPr>
          <a:lstStyle/>
          <a:p>
            <a:r>
              <a:rPr lang="en-US" sz="2800" dirty="0"/>
              <a:t>FSC SSC</a:t>
            </a:r>
            <a:br>
              <a:rPr lang="en-US" sz="2800" dirty="0"/>
            </a:br>
            <a:r>
              <a:rPr lang="en-US" sz="2800" dirty="0"/>
              <a:t>T cell gat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AE15832-9661-C04C-8A67-8A9E354A7C0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49187" y="0"/>
            <a:ext cx="8493625" cy="6858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21B1D5A-7B64-1F45-8B47-9C63DE44EE28}"/>
              </a:ext>
            </a:extLst>
          </p:cNvPr>
          <p:cNvSpPr txBox="1"/>
          <p:nvPr/>
        </p:nvSpPr>
        <p:spPr>
          <a:xfrm>
            <a:off x="3089190" y="3082157"/>
            <a:ext cx="963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ehic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E999D48-6D92-874D-9657-CFB6956CBC74}"/>
              </a:ext>
            </a:extLst>
          </p:cNvPr>
          <p:cNvSpPr txBox="1"/>
          <p:nvPr/>
        </p:nvSpPr>
        <p:spPr>
          <a:xfrm>
            <a:off x="5776079" y="3082157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ilimuma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CECD216-EAFD-2342-9FBA-E220A851A5BC}"/>
              </a:ext>
            </a:extLst>
          </p:cNvPr>
          <p:cNvSpPr txBox="1"/>
          <p:nvPr/>
        </p:nvSpPr>
        <p:spPr>
          <a:xfrm>
            <a:off x="8462968" y="3082157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7F64906-F93D-5C40-8CDB-AEB74EADE00B}"/>
              </a:ext>
            </a:extLst>
          </p:cNvPr>
          <p:cNvSpPr txBox="1"/>
          <p:nvPr/>
        </p:nvSpPr>
        <p:spPr>
          <a:xfrm>
            <a:off x="3089190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5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D78A091-3FA0-9949-AA2A-2276EE84DF8C}"/>
              </a:ext>
            </a:extLst>
          </p:cNvPr>
          <p:cNvSpPr txBox="1"/>
          <p:nvPr/>
        </p:nvSpPr>
        <p:spPr>
          <a:xfrm>
            <a:off x="5885936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AB3C7F-297F-E44A-B135-EA2B1F46C06E}"/>
              </a:ext>
            </a:extLst>
          </p:cNvPr>
          <p:cNvSpPr txBox="1"/>
          <p:nvPr/>
        </p:nvSpPr>
        <p:spPr>
          <a:xfrm>
            <a:off x="8682682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50 </a:t>
            </a:r>
            <a:r>
              <a:rPr lang="en-US" dirty="0" err="1"/>
              <a:t>uM</a:t>
            </a:r>
            <a:endParaRPr lang="en-US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FD7BA43-1C5F-BD42-94EB-B6FF3890BC63}"/>
              </a:ext>
            </a:extLst>
          </p:cNvPr>
          <p:cNvCxnSpPr>
            <a:cxnSpLocks/>
          </p:cNvCxnSpPr>
          <p:nvPr/>
        </p:nvCxnSpPr>
        <p:spPr>
          <a:xfrm flipV="1">
            <a:off x="558404" y="4511058"/>
            <a:ext cx="0" cy="12719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481C930A-92A8-E547-A15C-08608449A4BE}"/>
              </a:ext>
            </a:extLst>
          </p:cNvPr>
          <p:cNvCxnSpPr>
            <a:cxnSpLocks/>
          </p:cNvCxnSpPr>
          <p:nvPr/>
        </p:nvCxnSpPr>
        <p:spPr>
          <a:xfrm>
            <a:off x="558404" y="5984789"/>
            <a:ext cx="11574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6E3A9E7-1EED-4940-A0E9-FE4FB87B7E6A}"/>
              </a:ext>
            </a:extLst>
          </p:cNvPr>
          <p:cNvSpPr txBox="1"/>
          <p:nvPr/>
        </p:nvSpPr>
        <p:spPr>
          <a:xfrm>
            <a:off x="741405" y="6128951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SC-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E1B1C84-5FC8-0649-AAE6-681A4F6B7430}"/>
              </a:ext>
            </a:extLst>
          </p:cNvPr>
          <p:cNvSpPr txBox="1"/>
          <p:nvPr/>
        </p:nvSpPr>
        <p:spPr>
          <a:xfrm rot="16200000">
            <a:off x="-180152" y="4895222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SC-A</a:t>
            </a:r>
          </a:p>
        </p:txBody>
      </p:sp>
    </p:spTree>
    <p:extLst>
      <p:ext uri="{BB962C8B-B14F-4D97-AF65-F5344CB8AC3E}">
        <p14:creationId xmlns:p14="http://schemas.microsoft.com/office/powerpoint/2010/main" val="20591494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38A90-8A50-AE49-9A0E-5CDA090AF1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0260" y="2505423"/>
            <a:ext cx="1487424" cy="1325563"/>
          </a:xfrm>
        </p:spPr>
        <p:txBody>
          <a:bodyPr>
            <a:normAutofit/>
          </a:bodyPr>
          <a:lstStyle/>
          <a:p>
            <a:r>
              <a:rPr lang="en-US" sz="2400" dirty="0"/>
              <a:t>Treg to T conv ratio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AC1EAC2D-C25F-F54C-8118-212DA56BD23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7684" y="51816"/>
            <a:ext cx="8576631" cy="6858000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091DC596-D8A3-3649-93B6-722E73A0012F}"/>
              </a:ext>
            </a:extLst>
          </p:cNvPr>
          <p:cNvCxnSpPr/>
          <p:nvPr/>
        </p:nvCxnSpPr>
        <p:spPr>
          <a:xfrm flipV="1">
            <a:off x="558404" y="4511058"/>
            <a:ext cx="0" cy="12719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901C5E1E-B439-A64C-ADA0-960F48DEA8EC}"/>
              </a:ext>
            </a:extLst>
          </p:cNvPr>
          <p:cNvCxnSpPr>
            <a:cxnSpLocks/>
          </p:cNvCxnSpPr>
          <p:nvPr/>
        </p:nvCxnSpPr>
        <p:spPr>
          <a:xfrm>
            <a:off x="558404" y="5984789"/>
            <a:ext cx="11574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E36D7279-2CE7-F649-A131-3DD2C06BCB99}"/>
              </a:ext>
            </a:extLst>
          </p:cNvPr>
          <p:cNvSpPr txBox="1"/>
          <p:nvPr/>
        </p:nvSpPr>
        <p:spPr>
          <a:xfrm>
            <a:off x="741405" y="6128951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1862574-B361-104A-A782-7F9CD7EB400D}"/>
              </a:ext>
            </a:extLst>
          </p:cNvPr>
          <p:cNvSpPr txBox="1"/>
          <p:nvPr/>
        </p:nvSpPr>
        <p:spPr>
          <a:xfrm rot="16200000">
            <a:off x="-180152" y="4895222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oxP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1A7419-2FBC-5E41-A253-CE4831347412}"/>
              </a:ext>
            </a:extLst>
          </p:cNvPr>
          <p:cNvSpPr txBox="1"/>
          <p:nvPr/>
        </p:nvSpPr>
        <p:spPr>
          <a:xfrm>
            <a:off x="3089190" y="3082157"/>
            <a:ext cx="963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ehicl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53449E-8A3F-434C-81CF-346D0427779D}"/>
              </a:ext>
            </a:extLst>
          </p:cNvPr>
          <p:cNvSpPr txBox="1"/>
          <p:nvPr/>
        </p:nvSpPr>
        <p:spPr>
          <a:xfrm>
            <a:off x="5776079" y="3082157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ilimuma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93D8AF1-DFE5-C145-B2F9-361C5E154A47}"/>
              </a:ext>
            </a:extLst>
          </p:cNvPr>
          <p:cNvSpPr txBox="1"/>
          <p:nvPr/>
        </p:nvSpPr>
        <p:spPr>
          <a:xfrm>
            <a:off x="8462968" y="3082157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A5C23C-E352-6D41-8CFC-60DB4BD25B89}"/>
              </a:ext>
            </a:extLst>
          </p:cNvPr>
          <p:cNvSpPr txBox="1"/>
          <p:nvPr/>
        </p:nvSpPr>
        <p:spPr>
          <a:xfrm>
            <a:off x="3089190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5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4C0C36A-03ED-D74A-A8B0-92624966D90F}"/>
              </a:ext>
            </a:extLst>
          </p:cNvPr>
          <p:cNvSpPr txBox="1"/>
          <p:nvPr/>
        </p:nvSpPr>
        <p:spPr>
          <a:xfrm>
            <a:off x="5885936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03F0D71-581C-EB49-9C70-0FCCDBC40B9F}"/>
              </a:ext>
            </a:extLst>
          </p:cNvPr>
          <p:cNvSpPr txBox="1"/>
          <p:nvPr/>
        </p:nvSpPr>
        <p:spPr>
          <a:xfrm>
            <a:off x="8682682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50 </a:t>
            </a:r>
            <a:r>
              <a:rPr lang="en-US" dirty="0" err="1"/>
              <a:t>uM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49356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50CD8B-7244-A74A-8D1A-A6F92B56E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g to T conv ratio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5F1B4DEA-C89B-C94B-A513-DB77BA1050A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92885515"/>
              </p:ext>
            </p:extLst>
          </p:nvPr>
        </p:nvGraphicFramePr>
        <p:xfrm>
          <a:off x="3054350" y="4960398"/>
          <a:ext cx="6083300" cy="1422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6949">
                  <a:extLst>
                    <a:ext uri="{9D8B030D-6E8A-4147-A177-3AD203B41FA5}">
                      <a16:colId xmlns:a16="http://schemas.microsoft.com/office/drawing/2014/main" val="3053974376"/>
                    </a:ext>
                  </a:extLst>
                </a:gridCol>
                <a:gridCol w="1330722">
                  <a:extLst>
                    <a:ext uri="{9D8B030D-6E8A-4147-A177-3AD203B41FA5}">
                      <a16:colId xmlns:a16="http://schemas.microsoft.com/office/drawing/2014/main" val="2970673940"/>
                    </a:ext>
                  </a:extLst>
                </a:gridCol>
                <a:gridCol w="826949">
                  <a:extLst>
                    <a:ext uri="{9D8B030D-6E8A-4147-A177-3AD203B41FA5}">
                      <a16:colId xmlns:a16="http://schemas.microsoft.com/office/drawing/2014/main" val="3781485981"/>
                    </a:ext>
                  </a:extLst>
                </a:gridCol>
                <a:gridCol w="1549340">
                  <a:extLst>
                    <a:ext uri="{9D8B030D-6E8A-4147-A177-3AD203B41FA5}">
                      <a16:colId xmlns:a16="http://schemas.microsoft.com/office/drawing/2014/main" val="2187878180"/>
                    </a:ext>
                  </a:extLst>
                </a:gridCol>
                <a:gridCol w="1549340">
                  <a:extLst>
                    <a:ext uri="{9D8B030D-6E8A-4147-A177-3AD203B41FA5}">
                      <a16:colId xmlns:a16="http://schemas.microsoft.com/office/drawing/2014/main" val="218067580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reg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 conv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reg/Tcov rati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Tconv/Treg rati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2639986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Vehicl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6.6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.4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.48076923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2317596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6466436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pilimuma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.4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2.7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9039812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.44354838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5998816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9 1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2.4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3.1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8770301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.47580645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538576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9 5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0.9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9.6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421370968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.37320574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1794265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11 1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.5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0.7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45454545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493577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11 5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0.2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1.8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44019139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4.0980392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43608880"/>
                  </a:ext>
                </a:extLst>
              </a:tr>
            </a:tbl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B0CE25BB-CD24-494D-97B9-017AE233D7B2}"/>
              </a:ext>
            </a:extLst>
          </p:cNvPr>
          <p:cNvGraphicFramePr>
            <a:graphicFrameLocks/>
          </p:cNvGraphicFramePr>
          <p:nvPr/>
        </p:nvGraphicFramePr>
        <p:xfrm>
          <a:off x="3810000" y="2057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78063773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3A356-AF2A-3E40-A7A3-2DF9988284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5615" y="2377335"/>
            <a:ext cx="2021975" cy="1325563"/>
          </a:xfrm>
        </p:spPr>
        <p:txBody>
          <a:bodyPr>
            <a:normAutofit/>
          </a:bodyPr>
          <a:lstStyle/>
          <a:p>
            <a:r>
              <a:rPr lang="en-US" sz="2800"/>
              <a:t>T cells: CD3+CD8+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7FCA09A-42D4-2440-8277-F2513D3ACE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3175" y="0"/>
            <a:ext cx="8385650" cy="68580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9E7D554-969C-2143-8FF0-928A1EA4FC00}"/>
              </a:ext>
            </a:extLst>
          </p:cNvPr>
          <p:cNvSpPr txBox="1"/>
          <p:nvPr/>
        </p:nvSpPr>
        <p:spPr>
          <a:xfrm>
            <a:off x="3089190" y="3082157"/>
            <a:ext cx="963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Vehicle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4E3BBE2-8BB1-4544-8ED3-AB640A8D4FB2}"/>
              </a:ext>
            </a:extLst>
          </p:cNvPr>
          <p:cNvSpPr txBox="1"/>
          <p:nvPr/>
        </p:nvSpPr>
        <p:spPr>
          <a:xfrm>
            <a:off x="5776079" y="3082157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Ipilimuma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917A9E2-D8DC-AD4E-918B-76062A33D2CE}"/>
              </a:ext>
            </a:extLst>
          </p:cNvPr>
          <p:cNvSpPr txBox="1"/>
          <p:nvPr/>
        </p:nvSpPr>
        <p:spPr>
          <a:xfrm>
            <a:off x="8462968" y="3082157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9DFE170-D66A-A546-B009-13590E705DD9}"/>
              </a:ext>
            </a:extLst>
          </p:cNvPr>
          <p:cNvSpPr txBox="1"/>
          <p:nvPr/>
        </p:nvSpPr>
        <p:spPr>
          <a:xfrm>
            <a:off x="3089190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9 5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24C6BA-2EE5-6248-A053-95F792C6E473}"/>
              </a:ext>
            </a:extLst>
          </p:cNvPr>
          <p:cNvSpPr txBox="1"/>
          <p:nvPr/>
        </p:nvSpPr>
        <p:spPr>
          <a:xfrm>
            <a:off x="5885936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10 </a:t>
            </a:r>
            <a:r>
              <a:rPr lang="en-US" dirty="0" err="1"/>
              <a:t>uM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04B4EC0-5306-284E-9428-5559C355FB64}"/>
              </a:ext>
            </a:extLst>
          </p:cNvPr>
          <p:cNvSpPr txBox="1"/>
          <p:nvPr/>
        </p:nvSpPr>
        <p:spPr>
          <a:xfrm>
            <a:off x="8682682" y="6488668"/>
            <a:ext cx="1283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11 50 </a:t>
            </a:r>
            <a:r>
              <a:rPr lang="en-US" dirty="0" err="1"/>
              <a:t>uM</a:t>
            </a:r>
            <a:endParaRPr lang="en-US" dirty="0"/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5BE56AF4-00E5-9548-A501-3751ACCEAEF5}"/>
              </a:ext>
            </a:extLst>
          </p:cNvPr>
          <p:cNvCxnSpPr/>
          <p:nvPr/>
        </p:nvCxnSpPr>
        <p:spPr>
          <a:xfrm flipV="1">
            <a:off x="558404" y="4511058"/>
            <a:ext cx="0" cy="12719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C36FEC0D-F5CA-6746-84AA-9FC704F7FF22}"/>
              </a:ext>
            </a:extLst>
          </p:cNvPr>
          <p:cNvCxnSpPr>
            <a:cxnSpLocks/>
          </p:cNvCxnSpPr>
          <p:nvPr/>
        </p:nvCxnSpPr>
        <p:spPr>
          <a:xfrm>
            <a:off x="558404" y="5984789"/>
            <a:ext cx="11574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765F2F0-9874-C64D-A3E4-11AC33797A66}"/>
              </a:ext>
            </a:extLst>
          </p:cNvPr>
          <p:cNvSpPr txBox="1"/>
          <p:nvPr/>
        </p:nvSpPr>
        <p:spPr>
          <a:xfrm>
            <a:off x="741405" y="6128951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8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764A2EA-872A-C649-8326-5C29FF9D2C8D}"/>
              </a:ext>
            </a:extLst>
          </p:cNvPr>
          <p:cNvSpPr txBox="1"/>
          <p:nvPr/>
        </p:nvSpPr>
        <p:spPr>
          <a:xfrm rot="16200000">
            <a:off x="-180152" y="4895222"/>
            <a:ext cx="974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D3</a:t>
            </a:r>
          </a:p>
        </p:txBody>
      </p:sp>
    </p:spTree>
    <p:extLst>
      <p:ext uri="{BB962C8B-B14F-4D97-AF65-F5344CB8AC3E}">
        <p14:creationId xmlns:p14="http://schemas.microsoft.com/office/powerpoint/2010/main" val="327171474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81A44-3D4D-2247-BD1C-0A041F0A7B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54918"/>
            <a:ext cx="10515600" cy="1325563"/>
          </a:xfrm>
        </p:spPr>
        <p:txBody>
          <a:bodyPr/>
          <a:lstStyle/>
          <a:p>
            <a:pPr algn="ctr"/>
            <a:r>
              <a:rPr lang="en-US" dirty="0"/>
              <a:t>T cells: CD3+CD8+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0D7B18C-6955-2D40-A4D7-59747D2A4A0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103713030"/>
              </p:ext>
            </p:extLst>
          </p:nvPr>
        </p:nvGraphicFramePr>
        <p:xfrm>
          <a:off x="686238" y="2717800"/>
          <a:ext cx="2159000" cy="1422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458">
                  <a:extLst>
                    <a:ext uri="{9D8B030D-6E8A-4147-A177-3AD203B41FA5}">
                      <a16:colId xmlns:a16="http://schemas.microsoft.com/office/drawing/2014/main" val="2166489787"/>
                    </a:ext>
                  </a:extLst>
                </a:gridCol>
                <a:gridCol w="1331542">
                  <a:extLst>
                    <a:ext uri="{9D8B030D-6E8A-4147-A177-3AD203B41FA5}">
                      <a16:colId xmlns:a16="http://schemas.microsoft.com/office/drawing/2014/main" val="322234659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CD3+CD8+ %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7186055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Vehicle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.2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1980337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Ipilimuma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.8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580067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9 1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.7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7944562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A9 5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.6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98943427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11 1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2.90%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7913617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D11 50 uM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27.60%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02975228"/>
                  </a:ext>
                </a:extLst>
              </a:tr>
            </a:tbl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DA3DDCC3-7DD4-644F-9D55-F703BD270BF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5400068"/>
              </p:ext>
            </p:extLst>
          </p:nvPr>
        </p:nvGraphicFramePr>
        <p:xfrm>
          <a:off x="3817216" y="2065481"/>
          <a:ext cx="4557568" cy="27270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4985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F7B9B2C6527ED4B872425A61FB2348D" ma:contentTypeVersion="13" ma:contentTypeDescription="Create a new document." ma:contentTypeScope="" ma:versionID="eab3e5c1ba249a1d86109643abc49beb">
  <xsd:schema xmlns:xsd="http://www.w3.org/2001/XMLSchema" xmlns:xs="http://www.w3.org/2001/XMLSchema" xmlns:p="http://schemas.microsoft.com/office/2006/metadata/properties" xmlns:ns2="a1c1925a-ca81-4b92-a099-ee59e54d030a" xmlns:ns3="86f5bbeb-a984-4fb2-bd57-831a897c44b1" targetNamespace="http://schemas.microsoft.com/office/2006/metadata/properties" ma:root="true" ma:fieldsID="4bd9371b356dbe3cb9af3a490a76fa85" ns2:_="" ns3:_="">
    <xsd:import namespace="a1c1925a-ca81-4b92-a099-ee59e54d030a"/>
    <xsd:import namespace="86f5bbeb-a984-4fb2-bd57-831a897c44b1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MediaServiceOCR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1c1925a-ca81-4b92-a099-ee59e54d030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4b2c965b-d860-41d6-b67e-2baa6ffbc59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6f5bbeb-a984-4fb2-bd57-831a897c44b1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012befff-b5e3-44f3-a870-0e1b3c30fa1a}" ma:internalName="TaxCatchAll" ma:showField="CatchAllData" ma:web="86f5bbeb-a984-4fb2-bd57-831a897c44b1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86f5bbeb-a984-4fb2-bd57-831a897c44b1" xsi:nil="true"/>
    <lcf76f155ced4ddcb4097134ff3c332f xmlns="a1c1925a-ca81-4b92-a099-ee59e54d030a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C4329194-8774-4AD8-84AD-94D05B7DDBCC}"/>
</file>

<file path=customXml/itemProps2.xml><?xml version="1.0" encoding="utf-8"?>
<ds:datastoreItem xmlns:ds="http://schemas.openxmlformats.org/officeDocument/2006/customXml" ds:itemID="{C550CA9E-9823-4361-8C31-AD8C1CF8E218}"/>
</file>

<file path=customXml/itemProps3.xml><?xml version="1.0" encoding="utf-8"?>
<ds:datastoreItem xmlns:ds="http://schemas.openxmlformats.org/officeDocument/2006/customXml" ds:itemID="{71D392C2-2EE4-4A6A-885F-EDA28CDF16A2}"/>
</file>

<file path=docProps/app.xml><?xml version="1.0" encoding="utf-8"?>
<Properties xmlns="http://schemas.openxmlformats.org/officeDocument/2006/extended-properties" xmlns:vt="http://schemas.openxmlformats.org/officeDocument/2006/docPropsVTypes">
  <TotalTime>364</TotalTime>
  <Words>504</Words>
  <Application>Microsoft Office PowerPoint</Application>
  <PresentationFormat>Widescreen</PresentationFormat>
  <Paragraphs>151</Paragraphs>
  <Slides>11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CTLA-4 small molecule inhibitor pilot experiment</vt:lpstr>
      <vt:lpstr>Experimental layout</vt:lpstr>
      <vt:lpstr>Cytokine bead array: relative levels of supernatant IL-10 and IFN-g </vt:lpstr>
      <vt:lpstr>Relative levels of supernatant IFN-g at day 6</vt:lpstr>
      <vt:lpstr>FSC SSC T cell gate</vt:lpstr>
      <vt:lpstr>Treg to T conv ratio</vt:lpstr>
      <vt:lpstr>Treg to T conv ratio</vt:lpstr>
      <vt:lpstr>T cells: CD3+CD8+</vt:lpstr>
      <vt:lpstr>T cells: CD3+CD8+</vt:lpstr>
      <vt:lpstr>CD3+CD4+: CD25+FoxP3+</vt:lpstr>
      <vt:lpstr>CD3+CD4+: CD25+FoxP3+ Treg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TLA-4 small molecule inhibitor pilot experiment</dc:title>
  <dc:creator>Vazquez-Perez, Jonathan</dc:creator>
  <cp:lastModifiedBy>Sobhani, Navid</cp:lastModifiedBy>
  <cp:revision>25</cp:revision>
  <dcterms:created xsi:type="dcterms:W3CDTF">2022-01-18T18:13:56Z</dcterms:created>
  <dcterms:modified xsi:type="dcterms:W3CDTF">2023-03-14T19:00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F7B9B2C6527ED4B872425A61FB2348D</vt:lpwstr>
  </property>
</Properties>
</file>